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96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293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444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055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645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193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707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687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861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489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986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661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5B898-303D-4E2B-963A-C50235B85B34}" type="datetimeFigureOut">
              <a:rPr lang="en-US" smtClean="0"/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7D3A8-7968-4A4F-9F4F-D7A063F9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483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42836" y="3103418"/>
            <a:ext cx="8634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1 Fig</a:t>
            </a:r>
            <a:r>
              <a:rPr lang="en-US" dirty="0"/>
              <a:t>. Embryo survival upon induction of </a:t>
            </a:r>
            <a:r>
              <a:rPr lang="en-US" dirty="0" err="1"/>
              <a:t>shRNA</a:t>
            </a:r>
            <a:r>
              <a:rPr lang="en-US" dirty="0"/>
              <a:t> with different doses of doxycycline (n=3)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9544532"/>
              </p:ext>
            </p:extLst>
          </p:nvPr>
        </p:nvGraphicFramePr>
        <p:xfrm>
          <a:off x="2715491" y="966917"/>
          <a:ext cx="6530111" cy="192024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67325">
                  <a:extLst>
                    <a:ext uri="{9D8B030D-6E8A-4147-A177-3AD203B41FA5}">
                      <a16:colId xmlns:a16="http://schemas.microsoft.com/office/drawing/2014/main" val="3220071059"/>
                    </a:ext>
                  </a:extLst>
                </a:gridCol>
                <a:gridCol w="882504">
                  <a:extLst>
                    <a:ext uri="{9D8B030D-6E8A-4147-A177-3AD203B41FA5}">
                      <a16:colId xmlns:a16="http://schemas.microsoft.com/office/drawing/2014/main" val="2325403426"/>
                    </a:ext>
                  </a:extLst>
                </a:gridCol>
                <a:gridCol w="828668">
                  <a:extLst>
                    <a:ext uri="{9D8B030D-6E8A-4147-A177-3AD203B41FA5}">
                      <a16:colId xmlns:a16="http://schemas.microsoft.com/office/drawing/2014/main" val="4292344331"/>
                    </a:ext>
                  </a:extLst>
                </a:gridCol>
                <a:gridCol w="773774">
                  <a:extLst>
                    <a:ext uri="{9D8B030D-6E8A-4147-A177-3AD203B41FA5}">
                      <a16:colId xmlns:a16="http://schemas.microsoft.com/office/drawing/2014/main" val="2595715672"/>
                    </a:ext>
                  </a:extLst>
                </a:gridCol>
                <a:gridCol w="773774">
                  <a:extLst>
                    <a:ext uri="{9D8B030D-6E8A-4147-A177-3AD203B41FA5}">
                      <a16:colId xmlns:a16="http://schemas.microsoft.com/office/drawing/2014/main" val="1324087473"/>
                    </a:ext>
                  </a:extLst>
                </a:gridCol>
                <a:gridCol w="1804066">
                  <a:extLst>
                    <a:ext uri="{9D8B030D-6E8A-4147-A177-3AD203B41FA5}">
                      <a16:colId xmlns:a16="http://schemas.microsoft.com/office/drawing/2014/main" val="102719013"/>
                    </a:ext>
                  </a:extLst>
                </a:gridCol>
              </a:tblGrid>
              <a:tr h="241935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xycycline dose (µg/mL)</a:t>
                      </a: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resorption sites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live embryos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of Crry downregulation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80066176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36200409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78487452"/>
                  </a:ext>
                </a:extLst>
              </a:tr>
              <a:tr h="144145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80975776"/>
                  </a:ext>
                </a:extLst>
              </a:tr>
              <a:tr h="139065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</a:pPr>
                      <a:r>
                        <a:rPr lang="en-US" sz="1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l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95868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8580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5</TotalTime>
  <Words>62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nadakoppa, Manu Thimmappa</dc:creator>
  <cp:lastModifiedBy>chn off31</cp:lastModifiedBy>
  <cp:revision>19</cp:revision>
  <dcterms:created xsi:type="dcterms:W3CDTF">2020-04-10T03:36:13Z</dcterms:created>
  <dcterms:modified xsi:type="dcterms:W3CDTF">2020-07-27T08:21:29Z</dcterms:modified>
</cp:coreProperties>
</file>